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71E69-139F-495C-BDA1-BE822390D2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FBB19-79C0-41AB-8541-0765E00258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19E04-456C-4292-8210-C788083AEE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056BA-9ECD-4ABB-8324-E27800CC1A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3C52A-B961-410D-BDFD-CFC719D159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DBBF1-26D5-4DF9-B518-8B50181658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805DF-07CC-456B-B812-55F23CDB7B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C1633-2B10-4FBA-91C6-50A5A4D0B3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510E8-50EC-430F-9804-6AA77CF56A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67BEA-9A1A-485A-B4F8-1FE05BF7D8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534A9-C5CC-45ED-8087-962533BBB5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25239-6CC0-44FD-B1A4-8D28B82DAD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630CDE-E99C-40C2-828B-BAC1D2229E47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3"/>
          <p:cNvSpPr/>
          <p:nvPr/>
        </p:nvSpPr>
        <p:spPr>
          <a:xfrm>
            <a:off x="0" y="-243000"/>
            <a:ext cx="252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 2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53"/>
          <p:cNvSpPr/>
          <p:nvPr/>
        </p:nvSpPr>
        <p:spPr>
          <a:xfrm>
            <a:off x="684360" y="2565360"/>
            <a:ext cx="34272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39"/>
          <p:cNvGrpSpPr/>
          <p:nvPr/>
        </p:nvGrpSpPr>
        <p:grpSpPr>
          <a:xfrm>
            <a:off x="611280" y="189000"/>
            <a:ext cx="8339040" cy="4895640"/>
            <a:chOff x="611280" y="189000"/>
            <a:chExt cx="8339040" cy="4895640"/>
          </a:xfrm>
        </p:grpSpPr>
        <p:grpSp>
          <p:nvGrpSpPr>
            <p:cNvPr id="44" name="Group 13"/>
            <p:cNvGrpSpPr/>
            <p:nvPr/>
          </p:nvGrpSpPr>
          <p:grpSpPr>
            <a:xfrm>
              <a:off x="4932360" y="2924280"/>
              <a:ext cx="4017960" cy="1507320"/>
              <a:chOff x="4932360" y="2924280"/>
              <a:chExt cx="4017960" cy="1507320"/>
            </a:xfrm>
          </p:grpSpPr>
          <p:pic>
            <p:nvPicPr>
              <p:cNvPr id="45" name="Picture 19" descr=""/>
              <p:cNvPicPr/>
              <p:nvPr/>
            </p:nvPicPr>
            <p:blipFill>
              <a:blip r:embed="rId1">
                <a:lum contrast="10000"/>
              </a:blip>
              <a:srcRect l="66206" t="0" r="0" b="0"/>
              <a:stretch/>
            </p:blipFill>
            <p:spPr>
              <a:xfrm>
                <a:off x="5955480" y="2990520"/>
                <a:ext cx="838440" cy="461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1" descr=""/>
              <p:cNvPicPr/>
              <p:nvPr/>
            </p:nvPicPr>
            <p:blipFill>
              <a:blip r:embed="rId2">
                <a:lum contrast="10000"/>
              </a:blip>
              <a:srcRect l="63127" t="2400" r="0" b="0"/>
              <a:stretch/>
            </p:blipFill>
            <p:spPr>
              <a:xfrm>
                <a:off x="7011000" y="2924280"/>
                <a:ext cx="993600" cy="53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20" descr=""/>
              <p:cNvPicPr/>
              <p:nvPr/>
            </p:nvPicPr>
            <p:blipFill>
              <a:blip r:embed="rId3"/>
              <a:srcRect l="60868" t="33447" r="27480" b="20034"/>
              <a:stretch/>
            </p:blipFill>
            <p:spPr>
              <a:xfrm>
                <a:off x="5938920" y="3591360"/>
                <a:ext cx="929520" cy="534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22" descr=""/>
              <p:cNvPicPr/>
              <p:nvPr/>
            </p:nvPicPr>
            <p:blipFill>
              <a:blip r:embed="rId4"/>
              <a:srcRect l="24739" t="29032" r="64687" b="22241"/>
              <a:stretch/>
            </p:blipFill>
            <p:spPr>
              <a:xfrm>
                <a:off x="7097760" y="3498840"/>
                <a:ext cx="926280" cy="6411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9" name="Group 38"/>
              <p:cNvGrpSpPr/>
              <p:nvPr/>
            </p:nvGrpSpPr>
            <p:grpSpPr>
              <a:xfrm>
                <a:off x="7884720" y="3120480"/>
                <a:ext cx="885960" cy="527040"/>
                <a:chOff x="7884720" y="3120480"/>
                <a:chExt cx="885960" cy="527040"/>
              </a:xfrm>
            </p:grpSpPr>
            <p:sp>
              <p:nvSpPr>
                <p:cNvPr id="50" name="Text Box 25"/>
                <p:cNvSpPr/>
                <p:nvPr/>
              </p:nvSpPr>
              <p:spPr>
                <a:xfrm>
                  <a:off x="8093160" y="3120480"/>
                  <a:ext cx="677520" cy="52704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spcAft>
                      <a:spcPts val="1001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AU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0 kD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Line 30"/>
                <p:cNvSpPr/>
                <p:nvPr/>
              </p:nvSpPr>
              <p:spPr>
                <a:xfrm flipH="1">
                  <a:off x="7884720" y="3258720"/>
                  <a:ext cx="2412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2" name="Text Box 28"/>
              <p:cNvSpPr/>
              <p:nvPr/>
            </p:nvSpPr>
            <p:spPr>
              <a:xfrm>
                <a:off x="5025960" y="3720960"/>
                <a:ext cx="853200" cy="462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-Act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28"/>
              <p:cNvSpPr/>
              <p:nvPr/>
            </p:nvSpPr>
            <p:spPr>
              <a:xfrm>
                <a:off x="4932360" y="3132000"/>
                <a:ext cx="957960" cy="444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FRP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25"/>
              <p:cNvSpPr/>
              <p:nvPr/>
            </p:nvSpPr>
            <p:spPr>
              <a:xfrm>
                <a:off x="8168760" y="3679920"/>
                <a:ext cx="781560" cy="4273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 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24"/>
              <p:cNvSpPr/>
              <p:nvPr/>
            </p:nvSpPr>
            <p:spPr>
              <a:xfrm>
                <a:off x="5751360" y="3972600"/>
                <a:ext cx="1365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mpty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ct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25"/>
              <p:cNvSpPr/>
              <p:nvPr/>
            </p:nvSpPr>
            <p:spPr>
              <a:xfrm>
                <a:off x="6972120" y="4013280"/>
                <a:ext cx="125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30"/>
              <p:cNvSpPr/>
              <p:nvPr/>
            </p:nvSpPr>
            <p:spPr>
              <a:xfrm flipH="1">
                <a:off x="7979400" y="3799440"/>
                <a:ext cx="241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Group 41"/>
            <p:cNvGrpSpPr/>
            <p:nvPr/>
          </p:nvGrpSpPr>
          <p:grpSpPr>
            <a:xfrm>
              <a:off x="2627280" y="189000"/>
              <a:ext cx="4724280" cy="1922400"/>
              <a:chOff x="2627280" y="189000"/>
              <a:chExt cx="4724280" cy="1922400"/>
            </a:xfrm>
          </p:grpSpPr>
          <p:sp>
            <p:nvSpPr>
              <p:cNvPr id="59" name="Text Box 153"/>
              <p:cNvSpPr/>
              <p:nvPr/>
            </p:nvSpPr>
            <p:spPr>
              <a:xfrm>
                <a:off x="2627280" y="189000"/>
                <a:ext cx="342720" cy="35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1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0" name="Picture 15" descr=""/>
              <p:cNvPicPr/>
              <p:nvPr/>
            </p:nvPicPr>
            <p:blipFill>
              <a:blip r:embed="rId5">
                <a:lum contrast="20000"/>
              </a:blip>
              <a:stretch/>
            </p:blipFill>
            <p:spPr>
              <a:xfrm>
                <a:off x="4211640" y="936360"/>
                <a:ext cx="1461600" cy="548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" name="Picture 16" descr=""/>
              <p:cNvPicPr/>
              <p:nvPr/>
            </p:nvPicPr>
            <p:blipFill>
              <a:blip r:embed="rId6">
                <a:lum contrast="20000"/>
              </a:blip>
              <a:srcRect l="0" t="7826" r="0" b="30870"/>
              <a:stretch/>
            </p:blipFill>
            <p:spPr>
              <a:xfrm>
                <a:off x="4328280" y="333000"/>
                <a:ext cx="1440360" cy="57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Text Box 28"/>
              <p:cNvSpPr/>
              <p:nvPr/>
            </p:nvSpPr>
            <p:spPr>
              <a:xfrm>
                <a:off x="3182040" y="1612080"/>
                <a:ext cx="853200" cy="4618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-Act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3" name="Picture 31" descr=""/>
              <p:cNvPicPr/>
              <p:nvPr/>
            </p:nvPicPr>
            <p:blipFill>
              <a:blip r:embed="rId7">
                <a:lum bright="10000"/>
              </a:blip>
              <a:stretch/>
            </p:blipFill>
            <p:spPr>
              <a:xfrm>
                <a:off x="4139640" y="1557360"/>
                <a:ext cx="1440360" cy="479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Text Box 25"/>
              <p:cNvSpPr/>
              <p:nvPr/>
            </p:nvSpPr>
            <p:spPr>
              <a:xfrm>
                <a:off x="5940360" y="1125360"/>
                <a:ext cx="1325520" cy="526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 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30"/>
              <p:cNvSpPr/>
              <p:nvPr/>
            </p:nvSpPr>
            <p:spPr>
              <a:xfrm flipH="1">
                <a:off x="5731560" y="1263600"/>
                <a:ext cx="241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 Box 25"/>
              <p:cNvSpPr/>
              <p:nvPr/>
            </p:nvSpPr>
            <p:spPr>
              <a:xfrm>
                <a:off x="5940360" y="1684440"/>
                <a:ext cx="1197720" cy="4269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 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30"/>
              <p:cNvSpPr/>
              <p:nvPr/>
            </p:nvSpPr>
            <p:spPr>
              <a:xfrm flipH="1">
                <a:off x="5724000" y="1803960"/>
                <a:ext cx="241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 Box 25"/>
              <p:cNvSpPr/>
              <p:nvPr/>
            </p:nvSpPr>
            <p:spPr>
              <a:xfrm>
                <a:off x="6026040" y="579960"/>
                <a:ext cx="1325520" cy="526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 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30"/>
              <p:cNvSpPr/>
              <p:nvPr/>
            </p:nvSpPr>
            <p:spPr>
              <a:xfrm flipH="1">
                <a:off x="5817240" y="718560"/>
                <a:ext cx="241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 Box 49"/>
              <p:cNvSpPr/>
              <p:nvPr/>
            </p:nvSpPr>
            <p:spPr>
              <a:xfrm>
                <a:off x="3175920" y="449640"/>
                <a:ext cx="1080360" cy="2880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ntrol sFRP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 Box 49"/>
              <p:cNvSpPr/>
              <p:nvPr/>
            </p:nvSpPr>
            <p:spPr>
              <a:xfrm>
                <a:off x="3226680" y="926640"/>
                <a:ext cx="924480" cy="498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FRP4 post transfec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" name="Group 39"/>
            <p:cNvGrpSpPr/>
            <p:nvPr/>
          </p:nvGrpSpPr>
          <p:grpSpPr>
            <a:xfrm>
              <a:off x="611280" y="2565360"/>
              <a:ext cx="4248000" cy="2519280"/>
              <a:chOff x="611280" y="2565360"/>
              <a:chExt cx="4248000" cy="2519280"/>
            </a:xfrm>
          </p:grpSpPr>
          <p:pic>
            <p:nvPicPr>
              <p:cNvPr id="73" name="Chart 36" descr=""/>
              <p:cNvPicPr/>
              <p:nvPr/>
            </p:nvPicPr>
            <p:blipFill>
              <a:blip r:embed="rId8"/>
              <a:stretch/>
            </p:blipFill>
            <p:spPr>
              <a:xfrm>
                <a:off x="611280" y="2565360"/>
                <a:ext cx="4248000" cy="2519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4" name="Text Box 140"/>
              <p:cNvSpPr/>
              <p:nvPr/>
            </p:nvSpPr>
            <p:spPr>
              <a:xfrm>
                <a:off x="3661200" y="3963240"/>
                <a:ext cx="43488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2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Text Box 153"/>
            <p:cNvSpPr/>
            <p:nvPr/>
          </p:nvSpPr>
          <p:spPr>
            <a:xfrm>
              <a:off x="5580000" y="2548080"/>
              <a:ext cx="34308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Rectangle 1"/>
          <p:cNvSpPr/>
          <p:nvPr/>
        </p:nvSpPr>
        <p:spPr>
          <a:xfrm>
            <a:off x="720720" y="5240160"/>
            <a:ext cx="766764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presentative images cut from Western blots demonstrating (A)  sFRP4 protein expression was increased in the chemoresistant cell lines following transfection with sFRP4 plasmid; (B) sFRP4 mRNA expression of chemosensitive cell line A2780 was knocked down using  siRNA; (C) sFRP4 protein expression  of A2780 cells following siRNA treatmen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5"/>
          <p:cNvSpPr/>
          <p:nvPr/>
        </p:nvSpPr>
        <p:spPr>
          <a:xfrm>
            <a:off x="4343400" y="1989000"/>
            <a:ext cx="588960" cy="28764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AD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5"/>
          <p:cNvSpPr/>
          <p:nvPr/>
        </p:nvSpPr>
        <p:spPr>
          <a:xfrm>
            <a:off x="5035680" y="1992240"/>
            <a:ext cx="503280" cy="28908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C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7T04:31:30Z</dcterms:created>
  <dc:creator>farfuso</dc:creator>
  <dc:description/>
  <dc:language>en-US</dc:language>
  <cp:lastModifiedBy>arfuso</cp:lastModifiedBy>
  <dcterms:modified xsi:type="dcterms:W3CDTF">2012-09-06T11:14:55Z</dcterms:modified>
  <cp:revision>3</cp:revision>
  <dc:subject/>
  <dc:title>Slide 1</dc:title>
</cp:coreProperties>
</file>